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692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21271;&#28023;&#36947;&#22823;&#23398;\&#23455;&#39443;&#12487;&#12540;&#12479;\Real%20Time%20PCR\Result\1708-E1s-FTs-E1Lb-e3E4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21271;&#28023;&#36947;&#22823;&#23398;\&#23455;&#39443;&#12487;&#12540;&#12479;\Real%20Time%20PCR\Result\1708-E1s-FTs-E1Lb-e3E4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21271;&#28023;&#36947;&#22823;&#23398;\&#23455;&#39443;&#12487;&#12540;&#12479;\Real%20Time%20PCR\Result\1708-E1s-FTs-E1Lb-e3E4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21271;&#28023;&#36947;&#22823;&#23398;\&#23455;&#39443;&#12487;&#12540;&#12479;\Real%20Time%20PCR\Result\1708-E1s-FTs-E1Lb-e3E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646305025020661"/>
          <c:y val="0.16088888888888889"/>
          <c:w val="0.74278723810042779"/>
          <c:h val="0.6329042869641294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親系統FTs!$A$4</c:f>
              <c:strCache>
                <c:ptCount val="1"/>
                <c:pt idx="0">
                  <c:v>FT2a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0BD6-4C3E-99FB-BED231E1328E}"/>
              </c:ext>
            </c:extLst>
          </c:dPt>
          <c:dPt>
            <c:idx val="1"/>
            <c:invertIfNegative val="0"/>
            <c:bubble3D val="0"/>
            <c:spPr>
              <a:solidFill>
                <a:schemeClr val="tx2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0BD6-4C3E-99FB-BED231E1328E}"/>
              </c:ext>
            </c:extLst>
          </c:dPt>
          <c:errBars>
            <c:errBarType val="both"/>
            <c:errValType val="cust"/>
            <c:noEndCap val="0"/>
            <c:plus>
              <c:numRef>
                <c:f>親系統FTs!$G$4:$G$5</c:f>
                <c:numCache>
                  <c:formatCode>General</c:formatCode>
                  <c:ptCount val="2"/>
                  <c:pt idx="0">
                    <c:v>0.97190145819646989</c:v>
                  </c:pt>
                  <c:pt idx="1">
                    <c:v>0.1627154981350373</c:v>
                  </c:pt>
                </c:numCache>
              </c:numRef>
            </c:plus>
            <c:minus>
              <c:numRef>
                <c:f>親系統FTs!$G$4:$G$5</c:f>
                <c:numCache>
                  <c:formatCode>General</c:formatCode>
                  <c:ptCount val="2"/>
                  <c:pt idx="0">
                    <c:v>0.97190145819646989</c:v>
                  </c:pt>
                  <c:pt idx="1">
                    <c:v>0.16271549813503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親系統FTs!$H$19:$H$20</c:f>
              <c:strCache>
                <c:ptCount val="2"/>
                <c:pt idx="0">
                  <c:v>ZE</c:v>
                </c:pt>
                <c:pt idx="1">
                  <c:v>He3</c:v>
                </c:pt>
              </c:strCache>
            </c:strRef>
          </c:cat>
          <c:val>
            <c:numRef>
              <c:f>親系統FTs!$F$4:$F$5</c:f>
              <c:numCache>
                <c:formatCode>0.0000_ </c:formatCode>
                <c:ptCount val="2"/>
                <c:pt idx="0">
                  <c:v>10.761333333333335</c:v>
                </c:pt>
                <c:pt idx="1">
                  <c:v>1.14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0BD6-4C3E-99FB-BED231E132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8467072"/>
        <c:axId val="38468608"/>
      </c:barChart>
      <c:catAx>
        <c:axId val="384670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8468608"/>
        <c:crosses val="autoZero"/>
        <c:auto val="1"/>
        <c:lblAlgn val="ctr"/>
        <c:lblOffset val="100"/>
        <c:noMultiLvlLbl val="0"/>
      </c:catAx>
      <c:valAx>
        <c:axId val="384686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9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</a:t>
                </a:r>
                <a:endParaRPr lang="ja-JP" altLang="en-US" sz="9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_ 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8467072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646305025020661"/>
          <c:y val="0.16088888888888889"/>
          <c:w val="0.74278723810042779"/>
          <c:h val="0.6329042869641294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親系統FTs!$A$19</c:f>
              <c:strCache>
                <c:ptCount val="1"/>
                <c:pt idx="0">
                  <c:v>FT2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430B-489B-AE6C-5824CCF1F3F1}"/>
              </c:ext>
            </c:extLst>
          </c:dPt>
          <c:dPt>
            <c:idx val="1"/>
            <c:invertIfNegative val="0"/>
            <c:bubble3D val="0"/>
            <c:spPr>
              <a:solidFill>
                <a:srgbClr val="0070C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430B-489B-AE6C-5824CCF1F3F1}"/>
              </c:ext>
            </c:extLst>
          </c:dPt>
          <c:errBars>
            <c:errBarType val="both"/>
            <c:errValType val="cust"/>
            <c:noEndCap val="0"/>
            <c:plus>
              <c:numRef>
                <c:f>親系統FTs!$G$19:$G$20</c:f>
                <c:numCache>
                  <c:formatCode>General</c:formatCode>
                  <c:ptCount val="2"/>
                  <c:pt idx="0">
                    <c:v>0.76197688795512541</c:v>
                  </c:pt>
                  <c:pt idx="1">
                    <c:v>0.67315699010953878</c:v>
                  </c:pt>
                </c:numCache>
              </c:numRef>
            </c:plus>
            <c:minus>
              <c:numRef>
                <c:f>親系統FTs!$G$19:$G$20</c:f>
                <c:numCache>
                  <c:formatCode>General</c:formatCode>
                  <c:ptCount val="2"/>
                  <c:pt idx="0">
                    <c:v>0.76197688795512541</c:v>
                  </c:pt>
                  <c:pt idx="1">
                    <c:v>0.6731569901095387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親系統FTs!$H$19:$H$20</c:f>
              <c:strCache>
                <c:ptCount val="2"/>
                <c:pt idx="0">
                  <c:v>ZE</c:v>
                </c:pt>
                <c:pt idx="1">
                  <c:v>He3</c:v>
                </c:pt>
              </c:strCache>
            </c:strRef>
          </c:cat>
          <c:val>
            <c:numRef>
              <c:f>親系統FTs!$F$19:$F$20</c:f>
              <c:numCache>
                <c:formatCode>0.0000_ </c:formatCode>
                <c:ptCount val="2"/>
                <c:pt idx="0">
                  <c:v>14.565666666666667</c:v>
                </c:pt>
                <c:pt idx="1">
                  <c:v>3.82099999999999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430B-489B-AE6C-5824CCF1F3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9343232"/>
        <c:axId val="39344768"/>
      </c:barChart>
      <c:catAx>
        <c:axId val="393432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Yu Gothic UI" panose="020B0500000000000000" pitchFamily="50" charset="-128"/>
                <a:cs typeface="Times New Roman" panose="02020603050405020304" pitchFamily="18" charset="0"/>
              </a:defRPr>
            </a:pPr>
            <a:endParaRPr lang="ja-JP"/>
          </a:p>
        </c:txPr>
        <c:crossAx val="39344768"/>
        <c:crosses val="autoZero"/>
        <c:auto val="1"/>
        <c:lblAlgn val="ctr"/>
        <c:lblOffset val="100"/>
        <c:noMultiLvlLbl val="0"/>
      </c:catAx>
      <c:valAx>
        <c:axId val="3934476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9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</a:t>
                </a:r>
                <a:endParaRPr lang="ja-JP" altLang="en-US" sz="90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_ 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9343232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455212562097559"/>
          <c:y val="0.14311111111111111"/>
          <c:w val="0.73469816272965882"/>
          <c:h val="0.6506820647419073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親系統FTs!$I$4</c:f>
              <c:strCache>
                <c:ptCount val="1"/>
                <c:pt idx="0">
                  <c:v>FT5a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2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D1B5-4962-8DA6-1DD6C34D2162}"/>
              </c:ext>
            </c:extLst>
          </c:dPt>
          <c:errBars>
            <c:errBarType val="both"/>
            <c:errValType val="cust"/>
            <c:noEndCap val="0"/>
            <c:plus>
              <c:numRef>
                <c:f>親系統FTs!$O$4:$O$5</c:f>
                <c:numCache>
                  <c:formatCode>General</c:formatCode>
                  <c:ptCount val="2"/>
                  <c:pt idx="0">
                    <c:v>1.1691746376539893</c:v>
                  </c:pt>
                  <c:pt idx="1">
                    <c:v>0.40767320790609274</c:v>
                  </c:pt>
                </c:numCache>
              </c:numRef>
            </c:plus>
            <c:minus>
              <c:numRef>
                <c:f>親系統FTs!$O$4:$O$5</c:f>
                <c:numCache>
                  <c:formatCode>General</c:formatCode>
                  <c:ptCount val="2"/>
                  <c:pt idx="0">
                    <c:v>1.1691746376539893</c:v>
                  </c:pt>
                  <c:pt idx="1">
                    <c:v>0.4076732079060927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親系統FTs!$H$19:$H$20</c:f>
              <c:strCache>
                <c:ptCount val="2"/>
                <c:pt idx="0">
                  <c:v>ZE</c:v>
                </c:pt>
                <c:pt idx="1">
                  <c:v>He3</c:v>
                </c:pt>
              </c:strCache>
            </c:strRef>
          </c:cat>
          <c:val>
            <c:numRef>
              <c:f>親系統FTs!$N$4:$N$5</c:f>
              <c:numCache>
                <c:formatCode>0.0000_ </c:formatCode>
                <c:ptCount val="2"/>
                <c:pt idx="0">
                  <c:v>5.4359999999999999</c:v>
                </c:pt>
                <c:pt idx="1">
                  <c:v>1.645333333333333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D1B5-4962-8DA6-1DD6C34D21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9374848"/>
        <c:axId val="39376384"/>
      </c:barChart>
      <c:catAx>
        <c:axId val="393748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9376384"/>
        <c:crosses val="autoZero"/>
        <c:auto val="1"/>
        <c:lblAlgn val="ctr"/>
        <c:lblOffset val="100"/>
        <c:noMultiLvlLbl val="0"/>
      </c:catAx>
      <c:valAx>
        <c:axId val="393763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9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</a:t>
                </a:r>
                <a:endParaRPr lang="ja-JP" altLang="en-US" sz="9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_ 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374848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455212562097559"/>
          <c:y val="0.14311111111111111"/>
          <c:w val="0.73469816272965882"/>
          <c:h val="0.6506820647419073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親系統FTs!$I$19</c:f>
              <c:strCache>
                <c:ptCount val="1"/>
                <c:pt idx="0">
                  <c:v>FT5a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238A-400C-94E0-D35AF0E453B0}"/>
              </c:ext>
            </c:extLst>
          </c:dPt>
          <c:dPt>
            <c:idx val="1"/>
            <c:invertIfNegative val="0"/>
            <c:bubble3D val="0"/>
            <c:spPr>
              <a:solidFill>
                <a:srgbClr val="0070C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238A-400C-94E0-D35AF0E453B0}"/>
              </c:ext>
            </c:extLst>
          </c:dPt>
          <c:errBars>
            <c:errBarType val="both"/>
            <c:errValType val="cust"/>
            <c:noEndCap val="0"/>
            <c:plus>
              <c:numRef>
                <c:f>親系統FTs!$O$19:$O$20</c:f>
                <c:numCache>
                  <c:formatCode>General</c:formatCode>
                  <c:ptCount val="2"/>
                  <c:pt idx="0">
                    <c:v>0.99800489867424047</c:v>
                  </c:pt>
                  <c:pt idx="1">
                    <c:v>1.4372758182679397</c:v>
                  </c:pt>
                </c:numCache>
              </c:numRef>
            </c:plus>
            <c:minus>
              <c:numRef>
                <c:f>親系統FTs!$O$19:$O$20</c:f>
                <c:numCache>
                  <c:formatCode>General</c:formatCode>
                  <c:ptCount val="2"/>
                  <c:pt idx="0">
                    <c:v>0.99800489867424047</c:v>
                  </c:pt>
                  <c:pt idx="1">
                    <c:v>1.43727581826793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親系統FTs!$H$19:$H$20</c:f>
              <c:strCache>
                <c:ptCount val="2"/>
                <c:pt idx="0">
                  <c:v>ZE</c:v>
                </c:pt>
                <c:pt idx="1">
                  <c:v>He3</c:v>
                </c:pt>
              </c:strCache>
            </c:strRef>
          </c:cat>
          <c:val>
            <c:numRef>
              <c:f>親系統FTs!$N$19:$N$20</c:f>
              <c:numCache>
                <c:formatCode>0.0000_ </c:formatCode>
                <c:ptCount val="2"/>
                <c:pt idx="0">
                  <c:v>13.982666666666667</c:v>
                </c:pt>
                <c:pt idx="1">
                  <c:v>6.244666666666667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238A-400C-94E0-D35AF0E453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9411072"/>
        <c:axId val="39429248"/>
      </c:barChart>
      <c:catAx>
        <c:axId val="394110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9429248"/>
        <c:crosses val="autoZero"/>
        <c:auto val="1"/>
        <c:lblAlgn val="ctr"/>
        <c:lblOffset val="100"/>
        <c:noMultiLvlLbl val="0"/>
      </c:catAx>
      <c:valAx>
        <c:axId val="394292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9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</a:t>
                </a:r>
                <a:endParaRPr lang="ja-JP" altLang="en-US" sz="90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_ 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411072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5A5D3-0EE1-4BC3-8EA5-0F961A4D9CDB}" type="datetimeFigureOut">
              <a:rPr kumimoji="1" lang="ja-JP" altLang="en-US" smtClean="0"/>
              <a:t>2018/9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2FD3A-5823-439C-A21B-51D966A347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35243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5A5D3-0EE1-4BC3-8EA5-0F961A4D9CDB}" type="datetimeFigureOut">
              <a:rPr kumimoji="1" lang="ja-JP" altLang="en-US" smtClean="0"/>
              <a:t>2018/9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2FD3A-5823-439C-A21B-51D966A347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72665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5A5D3-0EE1-4BC3-8EA5-0F961A4D9CDB}" type="datetimeFigureOut">
              <a:rPr kumimoji="1" lang="ja-JP" altLang="en-US" smtClean="0"/>
              <a:t>2018/9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2FD3A-5823-439C-A21B-51D966A347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393034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自定义版式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 txBox="1">
            <a:spLocks noChangeArrowheads="1"/>
          </p:cNvSpPr>
          <p:nvPr userDrawn="1"/>
        </p:nvSpPr>
        <p:spPr bwMode="auto">
          <a:xfrm>
            <a:off x="-5698" y="7101411"/>
            <a:ext cx="9149699" cy="3618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51408" tIns="25704" rIns="51408" bIns="25704" numCol="1" anchor="ctr" anchorCtr="0" compatLnSpc="1">
            <a:prstTxWarp prst="textNoShape">
              <a:avLst/>
            </a:prstTxWarp>
          </a:bodyPr>
          <a:lstStyle>
            <a:lvl1pPr marL="0" indent="0" algn="ctr">
              <a:buFontTx/>
              <a:buNone/>
              <a:defRPr sz="2000" b="1">
                <a:solidFill>
                  <a:schemeClr val="bg1"/>
                </a:solidFill>
                <a:latin typeface="+mj-lt"/>
                <a:ea typeface="+mj-ea"/>
                <a:cs typeface="+mj-cs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000">
                <a:latin typeface="+mn-lt"/>
                <a:ea typeface="仿宋_GB2312" pitchFamily="49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latin typeface="+mn-lt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latin typeface="+mn-lt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latin typeface="+mn-lt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latin typeface="+mn-lt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latin typeface="+mn-lt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latin typeface="+mn-lt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latin typeface="+mn-lt"/>
              </a:defRPr>
            </a:lvl9pPr>
          </a:lstStyle>
          <a:p>
            <a:pPr marL="0" marR="0" lvl="0" indent="0" algn="l" defTabSz="685732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zh-CN" sz="2000" b="1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微软雅黑" panose="020B0503020204020204" pitchFamily="34" charset="-122"/>
              <a:ea typeface="微软雅黑" panose="020B0503020204020204" pitchFamily="34" charset="-122"/>
              <a:cs typeface="+mj-cs"/>
            </a:endParaRPr>
          </a:p>
        </p:txBody>
      </p:sp>
    </p:spTree>
    <p:extLst>
      <p:ext uri="{BB962C8B-B14F-4D97-AF65-F5344CB8AC3E}">
        <p14:creationId xmlns:p14="http://schemas.microsoft.com/office/powerpoint/2010/main" val="228204880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8" fill="hold" grpId="0" nodeType="after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7" dur="5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5A5D3-0EE1-4BC3-8EA5-0F961A4D9CDB}" type="datetimeFigureOut">
              <a:rPr kumimoji="1" lang="ja-JP" altLang="en-US" smtClean="0"/>
              <a:t>2018/9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2FD3A-5823-439C-A21B-51D966A347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9686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5A5D3-0EE1-4BC3-8EA5-0F961A4D9CDB}" type="datetimeFigureOut">
              <a:rPr kumimoji="1" lang="ja-JP" altLang="en-US" smtClean="0"/>
              <a:t>2018/9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2FD3A-5823-439C-A21B-51D966A347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10124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5A5D3-0EE1-4BC3-8EA5-0F961A4D9CDB}" type="datetimeFigureOut">
              <a:rPr kumimoji="1" lang="ja-JP" altLang="en-US" smtClean="0"/>
              <a:t>2018/9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2FD3A-5823-439C-A21B-51D966A347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12413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5A5D3-0EE1-4BC3-8EA5-0F961A4D9CDB}" type="datetimeFigureOut">
              <a:rPr kumimoji="1" lang="ja-JP" altLang="en-US" smtClean="0"/>
              <a:t>2018/9/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2FD3A-5823-439C-A21B-51D966A347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04151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5A5D3-0EE1-4BC3-8EA5-0F961A4D9CDB}" type="datetimeFigureOut">
              <a:rPr kumimoji="1" lang="ja-JP" altLang="en-US" smtClean="0"/>
              <a:t>2018/9/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2FD3A-5823-439C-A21B-51D966A347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1264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5A5D3-0EE1-4BC3-8EA5-0F961A4D9CDB}" type="datetimeFigureOut">
              <a:rPr kumimoji="1" lang="ja-JP" altLang="en-US" smtClean="0"/>
              <a:t>2018/9/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2FD3A-5823-439C-A21B-51D966A347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40299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5A5D3-0EE1-4BC3-8EA5-0F961A4D9CDB}" type="datetimeFigureOut">
              <a:rPr kumimoji="1" lang="ja-JP" altLang="en-US" smtClean="0"/>
              <a:t>2018/9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2FD3A-5823-439C-A21B-51D966A347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80774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5A5D3-0EE1-4BC3-8EA5-0F961A4D9CDB}" type="datetimeFigureOut">
              <a:rPr kumimoji="1" lang="ja-JP" altLang="en-US" smtClean="0"/>
              <a:t>2018/9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2FD3A-5823-439C-A21B-51D966A347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83966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5A5D3-0EE1-4BC3-8EA5-0F961A4D9CDB}" type="datetimeFigureOut">
              <a:rPr kumimoji="1" lang="ja-JP" altLang="en-US" smtClean="0"/>
              <a:t>2018/9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42FD3A-5823-439C-A21B-51D966A347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3474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グループ化 17"/>
          <p:cNvGrpSpPr/>
          <p:nvPr/>
        </p:nvGrpSpPr>
        <p:grpSpPr>
          <a:xfrm>
            <a:off x="1767422" y="942282"/>
            <a:ext cx="5394031" cy="4025245"/>
            <a:chOff x="976312" y="1610102"/>
            <a:chExt cx="5394031" cy="4025245"/>
          </a:xfrm>
        </p:grpSpPr>
        <p:sp>
          <p:nvSpPr>
            <p:cNvPr id="6" name="テキスト ボックス 5"/>
            <p:cNvSpPr txBox="1"/>
            <p:nvPr/>
          </p:nvSpPr>
          <p:spPr>
            <a:xfrm>
              <a:off x="1108009" y="1610102"/>
              <a:ext cx="11844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ja-JP" sz="14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</a:t>
              </a:r>
              <a:r>
                <a:rPr lang="en-US" altLang="ja-JP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eaf stage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" name="グループ化 1"/>
            <p:cNvGrpSpPr/>
            <p:nvPr/>
          </p:nvGrpSpPr>
          <p:grpSpPr>
            <a:xfrm>
              <a:off x="976312" y="1906592"/>
              <a:ext cx="2752725" cy="3728755"/>
              <a:chOff x="976312" y="1906592"/>
              <a:chExt cx="2752725" cy="3728755"/>
            </a:xfrm>
          </p:grpSpPr>
          <p:graphicFrame>
            <p:nvGraphicFramePr>
              <p:cNvPr id="4" name="グラフ 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262690756"/>
                  </p:ext>
                </p:extLst>
              </p:nvPr>
            </p:nvGraphicFramePr>
            <p:xfrm>
              <a:off x="976312" y="2095500"/>
              <a:ext cx="2752725" cy="14287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12" name="グラフ 1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985071631"/>
                  </p:ext>
                </p:extLst>
              </p:nvPr>
            </p:nvGraphicFramePr>
            <p:xfrm>
              <a:off x="976312" y="4187547"/>
              <a:ext cx="2752725" cy="14478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pSp>
            <p:nvGrpSpPr>
              <p:cNvPr id="17" name="グループ化 16"/>
              <p:cNvGrpSpPr/>
              <p:nvPr/>
            </p:nvGrpSpPr>
            <p:grpSpPr>
              <a:xfrm>
                <a:off x="2050827" y="2413278"/>
                <a:ext cx="1008000" cy="650087"/>
                <a:chOff x="3622452" y="1158240"/>
                <a:chExt cx="1008000" cy="650087"/>
              </a:xfrm>
            </p:grpSpPr>
            <p:cxnSp>
              <p:nvCxnSpPr>
                <p:cNvPr id="14" name="直線コネクタ 13"/>
                <p:cNvCxnSpPr/>
                <p:nvPr/>
              </p:nvCxnSpPr>
              <p:spPr>
                <a:xfrm>
                  <a:off x="3627528" y="1158240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直線コネクタ 14"/>
                <p:cNvCxnSpPr/>
                <p:nvPr/>
              </p:nvCxnSpPr>
              <p:spPr>
                <a:xfrm>
                  <a:off x="4625407" y="1160327"/>
                  <a:ext cx="0" cy="64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直線コネクタ 15"/>
                <p:cNvCxnSpPr/>
                <p:nvPr/>
              </p:nvCxnSpPr>
              <p:spPr>
                <a:xfrm>
                  <a:off x="3622452" y="1160253"/>
                  <a:ext cx="1008000" cy="89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" name="テキスト ボックス 19"/>
              <p:cNvSpPr txBox="1"/>
              <p:nvPr/>
            </p:nvSpPr>
            <p:spPr>
              <a:xfrm>
                <a:off x="2371030" y="2248312"/>
                <a:ext cx="38664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*</a:t>
                </a:r>
                <a:endParaRPr kumimoji="1" lang="ja-JP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1" name="グループ化 20"/>
              <p:cNvGrpSpPr/>
              <p:nvPr/>
            </p:nvGrpSpPr>
            <p:grpSpPr>
              <a:xfrm>
                <a:off x="2044477" y="4463540"/>
                <a:ext cx="1018830" cy="578013"/>
                <a:chOff x="3622452" y="1158240"/>
                <a:chExt cx="1018830" cy="578013"/>
              </a:xfrm>
            </p:grpSpPr>
            <p:cxnSp>
              <p:nvCxnSpPr>
                <p:cNvPr id="22" name="直線コネクタ 21"/>
                <p:cNvCxnSpPr/>
                <p:nvPr/>
              </p:nvCxnSpPr>
              <p:spPr>
                <a:xfrm>
                  <a:off x="3627528" y="1158240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直線コネクタ 22"/>
                <p:cNvCxnSpPr/>
                <p:nvPr/>
              </p:nvCxnSpPr>
              <p:spPr>
                <a:xfrm>
                  <a:off x="4641282" y="1160253"/>
                  <a:ext cx="0" cy="576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直線コネクタ 23"/>
                <p:cNvCxnSpPr/>
                <p:nvPr/>
              </p:nvCxnSpPr>
              <p:spPr>
                <a:xfrm>
                  <a:off x="3622452" y="1160253"/>
                  <a:ext cx="1008000" cy="89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5" name="テキスト ボックス 24"/>
              <p:cNvSpPr txBox="1"/>
              <p:nvPr/>
            </p:nvSpPr>
            <p:spPr>
              <a:xfrm>
                <a:off x="2383730" y="4308099"/>
                <a:ext cx="38664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*</a:t>
                </a:r>
                <a:endParaRPr kumimoji="1" lang="ja-JP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テキスト ボックス 36"/>
              <p:cNvSpPr txBox="1"/>
              <p:nvPr/>
            </p:nvSpPr>
            <p:spPr>
              <a:xfrm>
                <a:off x="1077557" y="1906592"/>
                <a:ext cx="65814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T2a</a:t>
                </a:r>
                <a:endParaRPr kumimoji="1" lang="ja-JP" altLang="en-US" sz="105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テキスト ボックス 37"/>
              <p:cNvSpPr txBox="1"/>
              <p:nvPr/>
            </p:nvSpPr>
            <p:spPr>
              <a:xfrm>
                <a:off x="1077557" y="4035845"/>
                <a:ext cx="65814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T2a</a:t>
                </a:r>
                <a:endParaRPr kumimoji="1" lang="ja-JP" altLang="en-US" sz="105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" name="グループ化 2"/>
            <p:cNvGrpSpPr/>
            <p:nvPr/>
          </p:nvGrpSpPr>
          <p:grpSpPr>
            <a:xfrm>
              <a:off x="3617618" y="1906173"/>
              <a:ext cx="2752725" cy="3729174"/>
              <a:chOff x="4557712" y="1906173"/>
              <a:chExt cx="2752725" cy="3729174"/>
            </a:xfrm>
          </p:grpSpPr>
          <p:graphicFrame>
            <p:nvGraphicFramePr>
              <p:cNvPr id="5" name="グラフ 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862531102"/>
                  </p:ext>
                </p:extLst>
              </p:nvPr>
            </p:nvGraphicFramePr>
            <p:xfrm>
              <a:off x="4557712" y="2095500"/>
              <a:ext cx="2752725" cy="14287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13" name="グラフ 1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858489208"/>
                  </p:ext>
                </p:extLst>
              </p:nvPr>
            </p:nvGraphicFramePr>
            <p:xfrm>
              <a:off x="4557712" y="4187547"/>
              <a:ext cx="2752725" cy="14478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pSp>
            <p:nvGrpSpPr>
              <p:cNvPr id="26" name="グループ化 25"/>
              <p:cNvGrpSpPr/>
              <p:nvPr/>
            </p:nvGrpSpPr>
            <p:grpSpPr>
              <a:xfrm>
                <a:off x="5644911" y="2260795"/>
                <a:ext cx="1008000" cy="650087"/>
                <a:chOff x="3622452" y="1158240"/>
                <a:chExt cx="1008000" cy="650087"/>
              </a:xfrm>
            </p:grpSpPr>
            <p:cxnSp>
              <p:nvCxnSpPr>
                <p:cNvPr id="27" name="直線コネクタ 26"/>
                <p:cNvCxnSpPr/>
                <p:nvPr/>
              </p:nvCxnSpPr>
              <p:spPr>
                <a:xfrm>
                  <a:off x="3627528" y="1158240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直線コネクタ 27"/>
                <p:cNvCxnSpPr/>
                <p:nvPr/>
              </p:nvCxnSpPr>
              <p:spPr>
                <a:xfrm>
                  <a:off x="4625407" y="1160327"/>
                  <a:ext cx="0" cy="64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直線コネクタ 28"/>
                <p:cNvCxnSpPr/>
                <p:nvPr/>
              </p:nvCxnSpPr>
              <p:spPr>
                <a:xfrm>
                  <a:off x="3622452" y="1160253"/>
                  <a:ext cx="1008000" cy="89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0" name="テキスト ボックス 29"/>
              <p:cNvSpPr txBox="1"/>
              <p:nvPr/>
            </p:nvSpPr>
            <p:spPr>
              <a:xfrm>
                <a:off x="6019327" y="2085470"/>
                <a:ext cx="25199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endParaRPr kumimoji="1" lang="ja-JP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1" name="グループ化 30"/>
              <p:cNvGrpSpPr/>
              <p:nvPr/>
            </p:nvGrpSpPr>
            <p:grpSpPr>
              <a:xfrm>
                <a:off x="5655087" y="4242666"/>
                <a:ext cx="1008000" cy="578087"/>
                <a:chOff x="3622452" y="1158240"/>
                <a:chExt cx="1008000" cy="578087"/>
              </a:xfrm>
            </p:grpSpPr>
            <p:cxnSp>
              <p:nvCxnSpPr>
                <p:cNvPr id="32" name="直線コネクタ 31"/>
                <p:cNvCxnSpPr/>
                <p:nvPr/>
              </p:nvCxnSpPr>
              <p:spPr>
                <a:xfrm>
                  <a:off x="3627528" y="1158240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直線コネクタ 32"/>
                <p:cNvCxnSpPr/>
                <p:nvPr/>
              </p:nvCxnSpPr>
              <p:spPr>
                <a:xfrm>
                  <a:off x="4625407" y="1160327"/>
                  <a:ext cx="0" cy="576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直線コネクタ 33"/>
                <p:cNvCxnSpPr/>
                <p:nvPr/>
              </p:nvCxnSpPr>
              <p:spPr>
                <a:xfrm>
                  <a:off x="3622452" y="1160253"/>
                  <a:ext cx="1008000" cy="89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5" name="テキスト ボックス 34"/>
              <p:cNvSpPr txBox="1"/>
              <p:nvPr/>
            </p:nvSpPr>
            <p:spPr>
              <a:xfrm>
                <a:off x="6013390" y="4085891"/>
                <a:ext cx="25199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endParaRPr kumimoji="1" lang="ja-JP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テキスト ボックス 38"/>
              <p:cNvSpPr txBox="1"/>
              <p:nvPr/>
            </p:nvSpPr>
            <p:spPr>
              <a:xfrm>
                <a:off x="4674451" y="1906173"/>
                <a:ext cx="65814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T5a</a:t>
                </a:r>
                <a:endParaRPr kumimoji="1" lang="ja-JP" altLang="en-US" sz="105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テキスト ボックス 39"/>
              <p:cNvSpPr txBox="1"/>
              <p:nvPr/>
            </p:nvSpPr>
            <p:spPr>
              <a:xfrm>
                <a:off x="4674451" y="3980726"/>
                <a:ext cx="65814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T5a</a:t>
                </a:r>
                <a:endParaRPr kumimoji="1" lang="ja-JP" altLang="en-US" sz="105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1" name="テキスト ボックス 40"/>
            <p:cNvSpPr txBox="1"/>
            <p:nvPr/>
          </p:nvSpPr>
          <p:spPr>
            <a:xfrm>
              <a:off x="1108009" y="3725872"/>
              <a:ext cx="11844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lang="en-US" altLang="ja-JP" sz="14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d</a:t>
              </a:r>
              <a:r>
                <a:rPr lang="en-US" altLang="ja-JP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leaf stage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9" name="正方形/長方形 18"/>
          <p:cNvSpPr/>
          <p:nvPr/>
        </p:nvSpPr>
        <p:spPr>
          <a:xfrm>
            <a:off x="1591559" y="5126530"/>
            <a:ext cx="589041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levels of </a:t>
            </a:r>
            <a:r>
              <a:rPr lang="en-US" altLang="ja-JP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T2a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ja-JP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T5a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t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econd and third leaf stages in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D-insensitive </a:t>
            </a:r>
            <a:r>
              <a:rPr lang="en-US" altLang="ja-JP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eika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ZE)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D-sensitive </a:t>
            </a:r>
            <a:r>
              <a:rPr lang="en-US" altLang="ja-JP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arosoy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NIL for </a:t>
            </a:r>
            <a:r>
              <a:rPr lang="en-US" altLang="ja-JP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3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H-</a:t>
            </a:r>
            <a:r>
              <a:rPr lang="en-US" altLang="ja-JP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3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der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-enriched LD (20 h) conditions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mRNA levels (mean and standard error, n = 3) are expressed as the ratios to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tubulin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nscript levels. *,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; ***,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5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6328475" y="2572720"/>
            <a:ext cx="415498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-</a:t>
            </a:r>
            <a:r>
              <a:rPr kumimoji="1" lang="en-US" altLang="ja-JP" sz="9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3</a:t>
            </a:r>
            <a:endParaRPr kumimoji="1" lang="ja-JP" altLang="en-US" sz="9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3655017" y="2590802"/>
            <a:ext cx="415498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-</a:t>
            </a:r>
            <a:r>
              <a:rPr kumimoji="1" lang="en-US" altLang="ja-JP" sz="9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3</a:t>
            </a:r>
            <a:endParaRPr kumimoji="1" lang="ja-JP" altLang="en-US" sz="9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3675681" y="4688239"/>
            <a:ext cx="415498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-</a:t>
            </a:r>
            <a:r>
              <a:rPr kumimoji="1" lang="en-US" altLang="ja-JP" sz="9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3</a:t>
            </a:r>
            <a:endParaRPr kumimoji="1" lang="ja-JP" altLang="en-US" sz="9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6331058" y="4688239"/>
            <a:ext cx="415498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-</a:t>
            </a:r>
            <a:r>
              <a:rPr kumimoji="1" lang="en-US" altLang="ja-JP" sz="9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3</a:t>
            </a:r>
            <a:endParaRPr kumimoji="1" lang="ja-JP" altLang="en-US" sz="9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96930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00</Words>
  <Application>Microsoft Office PowerPoint</Application>
  <PresentationFormat>画面に合わせる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be</dc:creator>
  <cp:lastModifiedBy>abe</cp:lastModifiedBy>
  <cp:revision>3</cp:revision>
  <dcterms:created xsi:type="dcterms:W3CDTF">2018-08-31T06:42:45Z</dcterms:created>
  <dcterms:modified xsi:type="dcterms:W3CDTF">2018-09-03T00:16:02Z</dcterms:modified>
</cp:coreProperties>
</file>